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notesMasterIdLst>
    <p:notesMasterId r:id="rId5"/>
  </p:notesMasterIdLst>
  <p:sldIdLst>
    <p:sldId id="264" r:id="rId2"/>
    <p:sldId id="261" r:id="rId3"/>
    <p:sldId id="262" r:id="rId4"/>
  </p:sldIdLst>
  <p:sldSz cx="7315200" cy="9720263"/>
  <p:notesSz cx="7010400" cy="9296400"/>
  <p:defaultTextStyle>
    <a:defPPr>
      <a:defRPr lang="cs-CZ"/>
    </a:defPPr>
    <a:lvl1pPr marL="0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7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5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3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2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0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78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47" algn="l" defTabSz="9143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72" userDrawn="1">
          <p15:clr>
            <a:srgbClr val="A4A3A4"/>
          </p15:clr>
        </p15:guide>
        <p15:guide id="2" pos="1575" userDrawn="1">
          <p15:clr>
            <a:srgbClr val="A4A3A4"/>
          </p15:clr>
        </p15:guide>
        <p15:guide id="3" orient="horz" pos="1530" userDrawn="1">
          <p15:clr>
            <a:srgbClr val="A4A3A4"/>
          </p15:clr>
        </p15:guide>
        <p15:guide id="4" pos="216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" initials="A" lastIdx="2" clrIdx="0">
    <p:extLst>
      <p:ext uri="{19B8F6BF-5375-455C-9EA6-DF929625EA0E}">
        <p15:presenceInfo xmlns:p15="http://schemas.microsoft.com/office/powerpoint/2012/main" xmlns="" userId="Adm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E7BE1"/>
    <a:srgbClr val="3C3CFF"/>
    <a:srgbClr val="FF9225"/>
    <a:srgbClr val="376500"/>
    <a:srgbClr val="848484"/>
    <a:srgbClr val="CCCCCC"/>
    <a:srgbClr val="FEBCBE"/>
    <a:srgbClr val="FE3436"/>
    <a:srgbClr val="B1FEAD"/>
    <a:srgbClr val="ACFE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15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05" autoAdjust="0"/>
    <p:restoredTop sz="94660"/>
  </p:normalViewPr>
  <p:slideViewPr>
    <p:cSldViewPr>
      <p:cViewPr varScale="1">
        <p:scale>
          <a:sx n="49" d="100"/>
          <a:sy n="49" d="100"/>
        </p:scale>
        <p:origin x="-1144" y="-96"/>
      </p:cViewPr>
      <p:guideLst>
        <p:guide orient="horz" pos="2172"/>
        <p:guide orient="horz" pos="1530"/>
        <p:guide pos="1575"/>
        <p:guide pos="21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commentAuthors" Target="commentAuthors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6FB3ECA-55B8-40D5-BA6D-A35F1B1F4377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4100" y="1162050"/>
            <a:ext cx="23622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cs-C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504E500-1D30-4509-9620-E08BCEC92111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41588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37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05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673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842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010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178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347" algn="l" defTabSz="914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90794"/>
            <a:ext cx="6217920" cy="3384092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105389"/>
            <a:ext cx="5486400" cy="2346813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4385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71472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17514"/>
            <a:ext cx="1577340" cy="823747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17514"/>
            <a:ext cx="4640580" cy="823747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67374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802800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423318"/>
            <a:ext cx="6309360" cy="404335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504929"/>
            <a:ext cx="6309360" cy="212630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27153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587570"/>
            <a:ext cx="3108960" cy="616741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587570"/>
            <a:ext cx="3108960" cy="616741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5384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17516"/>
            <a:ext cx="6309360" cy="18788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382815"/>
            <a:ext cx="3094672" cy="1167781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550596"/>
            <a:ext cx="3094672" cy="52223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382815"/>
            <a:ext cx="3109913" cy="1167781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550596"/>
            <a:ext cx="3109913" cy="52223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05201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69698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06199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48018"/>
            <a:ext cx="2359342" cy="2268061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99540"/>
            <a:ext cx="3703320" cy="6907687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916079"/>
            <a:ext cx="2359342" cy="540239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00018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48018"/>
            <a:ext cx="2359342" cy="2268061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99540"/>
            <a:ext cx="3703320" cy="6907687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916079"/>
            <a:ext cx="2359342" cy="540239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4722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17516"/>
            <a:ext cx="6309360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587570"/>
            <a:ext cx="6309360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009246"/>
            <a:ext cx="164592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98876-4C16-4044-B3F7-F290E21C6A09}" type="datetimeFigureOut">
              <a:rPr lang="cs-CZ" smtClean="0"/>
              <a:t>19/02/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009246"/>
            <a:ext cx="246888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009246"/>
            <a:ext cx="164592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97DD5-544F-457E-97B5-D2DD009AC3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91038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png"/><Relationship Id="rId20" Type="http://schemas.openxmlformats.org/officeDocument/2006/relationships/image" Target="../media/image14.tiff"/><Relationship Id="rId21" Type="http://schemas.openxmlformats.org/officeDocument/2006/relationships/oleObject" Target="../embeddings/oleObject1.bin"/><Relationship Id="rId22" Type="http://schemas.openxmlformats.org/officeDocument/2006/relationships/image" Target="../media/image2.emf"/><Relationship Id="rId10" Type="http://schemas.microsoft.com/office/2007/relationships/hdphoto" Target="../media/hdphoto3.wdp"/><Relationship Id="rId11" Type="http://schemas.openxmlformats.org/officeDocument/2006/relationships/image" Target="../media/image8.png"/><Relationship Id="rId12" Type="http://schemas.microsoft.com/office/2007/relationships/hdphoto" Target="../media/hdphoto4.wdp"/><Relationship Id="rId13" Type="http://schemas.openxmlformats.org/officeDocument/2006/relationships/image" Target="../media/image9.png"/><Relationship Id="rId14" Type="http://schemas.microsoft.com/office/2007/relationships/hdphoto" Target="../media/hdphoto5.wdp"/><Relationship Id="rId15" Type="http://schemas.openxmlformats.org/officeDocument/2006/relationships/image" Target="../media/image10.png"/><Relationship Id="rId16" Type="http://schemas.microsoft.com/office/2007/relationships/hdphoto" Target="../media/hdphoto6.wdp"/><Relationship Id="rId17" Type="http://schemas.openxmlformats.org/officeDocument/2006/relationships/image" Target="../media/image11.tiff"/><Relationship Id="rId18" Type="http://schemas.openxmlformats.org/officeDocument/2006/relationships/image" Target="../media/image12.tiff"/><Relationship Id="rId19" Type="http://schemas.openxmlformats.org/officeDocument/2006/relationships/image" Target="../media/image13.tif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Relationship Id="rId3" Type="http://schemas.openxmlformats.org/officeDocument/2006/relationships/image" Target="../media/image3.tiff"/><Relationship Id="rId4" Type="http://schemas.openxmlformats.org/officeDocument/2006/relationships/image" Target="../media/image4.png"/><Relationship Id="rId5" Type="http://schemas.microsoft.com/office/2007/relationships/hdphoto" Target="../media/hdphoto1.wdp"/><Relationship Id="rId6" Type="http://schemas.openxmlformats.org/officeDocument/2006/relationships/image" Target="../media/image5.png"/><Relationship Id="rId7" Type="http://schemas.microsoft.com/office/2007/relationships/hdphoto" Target="../media/hdphoto2.wdp"/><Relationship Id="rId8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4.tiff"/><Relationship Id="rId12" Type="http://schemas.openxmlformats.org/officeDocument/2006/relationships/image" Target="../media/image25.tiff"/><Relationship Id="rId13" Type="http://schemas.openxmlformats.org/officeDocument/2006/relationships/image" Target="../media/image26.tiff"/><Relationship Id="rId14" Type="http://schemas.openxmlformats.org/officeDocument/2006/relationships/image" Target="../media/image27.tiff"/><Relationship Id="rId15" Type="http://schemas.openxmlformats.org/officeDocument/2006/relationships/oleObject" Target="../embeddings/oleObject2.bin"/><Relationship Id="rId16" Type="http://schemas.openxmlformats.org/officeDocument/2006/relationships/image" Target="../media/image15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1.xml"/><Relationship Id="rId3" Type="http://schemas.openxmlformats.org/officeDocument/2006/relationships/image" Target="../media/image16.tiff"/><Relationship Id="rId4" Type="http://schemas.openxmlformats.org/officeDocument/2006/relationships/image" Target="../media/image17.tiff"/><Relationship Id="rId5" Type="http://schemas.openxmlformats.org/officeDocument/2006/relationships/image" Target="../media/image18.tiff"/><Relationship Id="rId6" Type="http://schemas.openxmlformats.org/officeDocument/2006/relationships/image" Target="../media/image19.tiff"/><Relationship Id="rId7" Type="http://schemas.openxmlformats.org/officeDocument/2006/relationships/image" Target="../media/image20.tiff"/><Relationship Id="rId8" Type="http://schemas.openxmlformats.org/officeDocument/2006/relationships/image" Target="../media/image21.tiff"/><Relationship Id="rId9" Type="http://schemas.openxmlformats.org/officeDocument/2006/relationships/image" Target="../media/image22.tiff"/><Relationship Id="rId10" Type="http://schemas.openxmlformats.org/officeDocument/2006/relationships/image" Target="../media/image2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TextBox 8"/>
          <p:cNvSpPr txBox="1"/>
          <p:nvPr/>
        </p:nvSpPr>
        <p:spPr>
          <a:xfrm>
            <a:off x="18618" y="44694"/>
            <a:ext cx="278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234525" y="5587974"/>
            <a:ext cx="6527225" cy="93358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viv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setup using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Two experimental groups were injected daily (14 days) with either GDF11 (0,1 mg/kg) or saline (n=12 per group).</a:t>
            </a:r>
          </a:p>
          <a:p>
            <a:pPr algn="just">
              <a:spcAft>
                <a:spcPts val="800"/>
              </a:spcAft>
            </a:pPr>
            <a:endParaRPr lang="en-US" sz="1200" dirty="0" smtClean="0">
              <a:solidFill>
                <a:schemeClr val="tx1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423467" y="761903"/>
            <a:ext cx="6149340" cy="3857316"/>
            <a:chOff x="518409" y="645684"/>
            <a:chExt cx="6149340" cy="3857316"/>
          </a:xfrm>
        </p:grpSpPr>
        <p:pic>
          <p:nvPicPr>
            <p:cNvPr id="105" name="Picture 104"/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5497" y="3085304"/>
              <a:ext cx="991297" cy="977675"/>
            </a:xfrm>
            <a:prstGeom prst="rect">
              <a:avLst/>
            </a:prstGeom>
          </p:spPr>
        </p:pic>
        <p:grpSp>
          <p:nvGrpSpPr>
            <p:cNvPr id="35" name="Group 34"/>
            <p:cNvGrpSpPr/>
            <p:nvPr/>
          </p:nvGrpSpPr>
          <p:grpSpPr>
            <a:xfrm>
              <a:off x="725497" y="1168229"/>
              <a:ext cx="991296" cy="1237305"/>
              <a:chOff x="3179916" y="1610827"/>
              <a:chExt cx="1460061" cy="1822405"/>
            </a:xfrm>
          </p:grpSpPr>
          <p:pic>
            <p:nvPicPr>
              <p:cNvPr id="101" name="Picture 100"/>
              <p:cNvPicPr>
                <a:picLocks noChangeAspect="1"/>
              </p:cNvPicPr>
              <p:nvPr/>
            </p:nvPicPr>
            <p:blipFill>
              <a:blip r:embed="rId2" cstate="screen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79916" y="1610827"/>
                <a:ext cx="1460061" cy="1440000"/>
              </a:xfrm>
              <a:prstGeom prst="rect">
                <a:avLst/>
              </a:prstGeom>
            </p:spPr>
          </p:pic>
          <p:sp>
            <p:nvSpPr>
              <p:cNvPr id="104" name="TextBox 103"/>
              <p:cNvSpPr txBox="1"/>
              <p:nvPr/>
            </p:nvSpPr>
            <p:spPr>
              <a:xfrm>
                <a:off x="3529055" y="3025245"/>
                <a:ext cx="1020438" cy="4079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b="1" dirty="0" err="1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b</a:t>
                </a:r>
                <a:r>
                  <a:rPr lang="en-US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1200" b="1" dirty="0" err="1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b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1694256" y="2560038"/>
              <a:ext cx="28245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GDF11 injection (0.1mg/Kg)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736853" y="645684"/>
              <a:ext cx="23619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Saline injection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409" y="1524557"/>
              <a:ext cx="7345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N=12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31090" y="3468945"/>
              <a:ext cx="7218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N=12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ight Arrow 42"/>
            <p:cNvSpPr/>
            <p:nvPr/>
          </p:nvSpPr>
          <p:spPr>
            <a:xfrm>
              <a:off x="5319000" y="1306431"/>
              <a:ext cx="420406" cy="104579"/>
            </a:xfrm>
            <a:prstGeom prst="rightArrow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241595" y="1349645"/>
              <a:ext cx="5768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GTT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&quot;No&quot; Symbol 44"/>
            <p:cNvSpPr/>
            <p:nvPr/>
          </p:nvSpPr>
          <p:spPr>
            <a:xfrm>
              <a:off x="5852880" y="1187039"/>
              <a:ext cx="503324" cy="503324"/>
            </a:xfrm>
            <a:prstGeom prst="noSmoking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875055" y="1224566"/>
              <a:ext cx="554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ight Arrow 46"/>
            <p:cNvSpPr/>
            <p:nvPr/>
          </p:nvSpPr>
          <p:spPr>
            <a:xfrm>
              <a:off x="5330521" y="1850851"/>
              <a:ext cx="405234" cy="108380"/>
            </a:xfrm>
            <a:prstGeom prst="rightArrow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250467" y="1919594"/>
              <a:ext cx="5387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ITT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869993" y="1748897"/>
              <a:ext cx="580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Group 49"/>
            <p:cNvGrpSpPr/>
            <p:nvPr/>
          </p:nvGrpSpPr>
          <p:grpSpPr>
            <a:xfrm>
              <a:off x="1712970" y="895872"/>
              <a:ext cx="3277792" cy="1246448"/>
              <a:chOff x="1789309" y="1622800"/>
              <a:chExt cx="11015996" cy="1090040"/>
            </a:xfrm>
          </p:grpSpPr>
          <p:sp>
            <p:nvSpPr>
              <p:cNvPr id="82" name="Right Arrow 81"/>
              <p:cNvSpPr/>
              <p:nvPr/>
            </p:nvSpPr>
            <p:spPr>
              <a:xfrm>
                <a:off x="2181000" y="2124000"/>
                <a:ext cx="10011000" cy="346600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1789309" y="2438309"/>
                <a:ext cx="1822009" cy="242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1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10697766" y="2454454"/>
                <a:ext cx="2107539" cy="242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14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6243539" y="2470600"/>
                <a:ext cx="1822009" cy="242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7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" name="Straight Arrow Connector 85"/>
              <p:cNvCxnSpPr/>
              <p:nvPr/>
            </p:nvCxnSpPr>
            <p:spPr>
              <a:xfrm>
                <a:off x="2181000" y="16290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Arrow Connector 86"/>
              <p:cNvCxnSpPr/>
              <p:nvPr/>
            </p:nvCxnSpPr>
            <p:spPr>
              <a:xfrm>
                <a:off x="371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Arrow Connector 87"/>
              <p:cNvCxnSpPr/>
              <p:nvPr/>
            </p:nvCxnSpPr>
            <p:spPr>
              <a:xfrm>
                <a:off x="2946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Arrow Connector 88"/>
              <p:cNvCxnSpPr/>
              <p:nvPr/>
            </p:nvCxnSpPr>
            <p:spPr>
              <a:xfrm>
                <a:off x="605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Arrow Connector 89"/>
              <p:cNvCxnSpPr/>
              <p:nvPr/>
            </p:nvCxnSpPr>
            <p:spPr>
              <a:xfrm>
                <a:off x="443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Arrow Connector 90"/>
              <p:cNvCxnSpPr/>
              <p:nvPr/>
            </p:nvCxnSpPr>
            <p:spPr>
              <a:xfrm>
                <a:off x="524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Arrow Connector 91"/>
              <p:cNvCxnSpPr/>
              <p:nvPr/>
            </p:nvCxnSpPr>
            <p:spPr>
              <a:xfrm>
                <a:off x="1212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Arrow Connector 92"/>
              <p:cNvCxnSpPr/>
              <p:nvPr/>
            </p:nvCxnSpPr>
            <p:spPr>
              <a:xfrm>
                <a:off x="6816000" y="16290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Arrow Connector 93"/>
              <p:cNvCxnSpPr/>
              <p:nvPr/>
            </p:nvCxnSpPr>
            <p:spPr>
              <a:xfrm>
                <a:off x="7536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Arrow Connector 94"/>
              <p:cNvCxnSpPr/>
              <p:nvPr/>
            </p:nvCxnSpPr>
            <p:spPr>
              <a:xfrm>
                <a:off x="906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Arrow Connector 95"/>
              <p:cNvCxnSpPr/>
              <p:nvPr/>
            </p:nvCxnSpPr>
            <p:spPr>
              <a:xfrm>
                <a:off x="8301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Arrow Connector 96"/>
              <p:cNvCxnSpPr/>
              <p:nvPr/>
            </p:nvCxnSpPr>
            <p:spPr>
              <a:xfrm>
                <a:off x="1140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Arrow Connector 97"/>
              <p:cNvCxnSpPr/>
              <p:nvPr/>
            </p:nvCxnSpPr>
            <p:spPr>
              <a:xfrm>
                <a:off x="978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Arrow Connector 98"/>
              <p:cNvCxnSpPr/>
              <p:nvPr/>
            </p:nvCxnSpPr>
            <p:spPr>
              <a:xfrm>
                <a:off x="1059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Box 50"/>
            <p:cNvSpPr txBox="1"/>
            <p:nvPr/>
          </p:nvSpPr>
          <p:spPr>
            <a:xfrm>
              <a:off x="5586433" y="1648615"/>
              <a:ext cx="10813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gan harvest</a:t>
              </a:r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1657365" y="2816531"/>
              <a:ext cx="3277792" cy="1246448"/>
              <a:chOff x="1789309" y="1622800"/>
              <a:chExt cx="11015996" cy="1090040"/>
            </a:xfrm>
          </p:grpSpPr>
          <p:sp>
            <p:nvSpPr>
              <p:cNvPr id="64" name="Right Arrow 63"/>
              <p:cNvSpPr/>
              <p:nvPr/>
            </p:nvSpPr>
            <p:spPr>
              <a:xfrm>
                <a:off x="2181000" y="2124000"/>
                <a:ext cx="10011000" cy="346600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789309" y="2438309"/>
                <a:ext cx="1822009" cy="242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1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0697766" y="2454454"/>
                <a:ext cx="2107539" cy="242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14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6243539" y="2470600"/>
                <a:ext cx="1822009" cy="242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7</a:t>
                </a:r>
                <a:endParaRPr lang="en-GB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8" name="Straight Arrow Connector 67"/>
              <p:cNvCxnSpPr/>
              <p:nvPr/>
            </p:nvCxnSpPr>
            <p:spPr>
              <a:xfrm>
                <a:off x="2181000" y="16290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Arrow Connector 68"/>
              <p:cNvCxnSpPr/>
              <p:nvPr/>
            </p:nvCxnSpPr>
            <p:spPr>
              <a:xfrm>
                <a:off x="371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Arrow Connector 69"/>
              <p:cNvCxnSpPr/>
              <p:nvPr/>
            </p:nvCxnSpPr>
            <p:spPr>
              <a:xfrm>
                <a:off x="2946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/>
              <p:cNvCxnSpPr/>
              <p:nvPr/>
            </p:nvCxnSpPr>
            <p:spPr>
              <a:xfrm>
                <a:off x="605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/>
              <p:cNvCxnSpPr/>
              <p:nvPr/>
            </p:nvCxnSpPr>
            <p:spPr>
              <a:xfrm>
                <a:off x="443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Arrow Connector 72"/>
              <p:cNvCxnSpPr/>
              <p:nvPr/>
            </p:nvCxnSpPr>
            <p:spPr>
              <a:xfrm>
                <a:off x="5241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Arrow Connector 73"/>
              <p:cNvCxnSpPr/>
              <p:nvPr/>
            </p:nvCxnSpPr>
            <p:spPr>
              <a:xfrm>
                <a:off x="1212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Arrow Connector 74"/>
              <p:cNvCxnSpPr/>
              <p:nvPr/>
            </p:nvCxnSpPr>
            <p:spPr>
              <a:xfrm>
                <a:off x="6816000" y="16290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Arrow Connector 75"/>
              <p:cNvCxnSpPr/>
              <p:nvPr/>
            </p:nvCxnSpPr>
            <p:spPr>
              <a:xfrm>
                <a:off x="7536000" y="16259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Arrow Connector 76"/>
              <p:cNvCxnSpPr/>
              <p:nvPr/>
            </p:nvCxnSpPr>
            <p:spPr>
              <a:xfrm>
                <a:off x="906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Arrow Connector 77"/>
              <p:cNvCxnSpPr/>
              <p:nvPr/>
            </p:nvCxnSpPr>
            <p:spPr>
              <a:xfrm>
                <a:off x="8301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Arrow Connector 78"/>
              <p:cNvCxnSpPr/>
              <p:nvPr/>
            </p:nvCxnSpPr>
            <p:spPr>
              <a:xfrm>
                <a:off x="1140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Arrow Connector 79"/>
              <p:cNvCxnSpPr/>
              <p:nvPr/>
            </p:nvCxnSpPr>
            <p:spPr>
              <a:xfrm>
                <a:off x="978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Arrow Connector 80"/>
              <p:cNvCxnSpPr/>
              <p:nvPr/>
            </p:nvCxnSpPr>
            <p:spPr>
              <a:xfrm>
                <a:off x="10596000" y="1622800"/>
                <a:ext cx="0" cy="495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4" name="TextBox 53"/>
            <p:cNvSpPr txBox="1"/>
            <p:nvPr/>
          </p:nvSpPr>
          <p:spPr>
            <a:xfrm>
              <a:off x="5107121" y="2267035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Day15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ight Arrow 54"/>
            <p:cNvSpPr/>
            <p:nvPr/>
          </p:nvSpPr>
          <p:spPr>
            <a:xfrm>
              <a:off x="5303594" y="3265398"/>
              <a:ext cx="420406" cy="104579"/>
            </a:xfrm>
            <a:prstGeom prst="rightArrow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&quot;No&quot; Symbol 55"/>
            <p:cNvSpPr/>
            <p:nvPr/>
          </p:nvSpPr>
          <p:spPr>
            <a:xfrm>
              <a:off x="5828823" y="3168892"/>
              <a:ext cx="503324" cy="503324"/>
            </a:xfrm>
            <a:prstGeom prst="noSmoking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850085" y="3183532"/>
              <a:ext cx="554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ight Arrow 57"/>
            <p:cNvSpPr/>
            <p:nvPr/>
          </p:nvSpPr>
          <p:spPr>
            <a:xfrm>
              <a:off x="5305550" y="3809817"/>
              <a:ext cx="405234" cy="108380"/>
            </a:xfrm>
            <a:prstGeom prst="rightArrow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845023" y="3707863"/>
              <a:ext cx="5404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574246" y="3645962"/>
              <a:ext cx="10813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gan harvest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082152" y="4226001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Day15</a:t>
              </a:r>
              <a:endPara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171549" y="3301421"/>
              <a:ext cx="635570" cy="314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444" dirty="0"/>
                <a:t>GTT</a:t>
              </a:r>
              <a:endParaRPr lang="en-GB" sz="1444" b="1" dirty="0">
                <a:solidFill>
                  <a:srgbClr val="FF0000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195489" y="3862883"/>
              <a:ext cx="622985" cy="314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444" dirty="0"/>
                <a:t>ITT</a:t>
              </a:r>
              <a:endParaRPr lang="en-GB" sz="1444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100" name="TextBox 99"/>
          <p:cNvSpPr txBox="1"/>
          <p:nvPr/>
        </p:nvSpPr>
        <p:spPr>
          <a:xfrm>
            <a:off x="610901" y="4186917"/>
            <a:ext cx="1282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GDF11</a:t>
            </a:r>
            <a:endParaRPr lang="en-GB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8712235"/>
      </p:ext>
    </p:extLst>
  </p:cSld>
  <p:clrMapOvr>
    <a:masterClrMapping/>
  </p:clrMapOvr>
  <p:transition xmlns:p14="http://schemas.microsoft.com/office/powerpoint/2010/main" spd="slow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8"/>
          <p:cNvSpPr txBox="1"/>
          <p:nvPr/>
        </p:nvSpPr>
        <p:spPr>
          <a:xfrm>
            <a:off x="151708" y="6445652"/>
            <a:ext cx="247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8"/>
          <p:cNvSpPr txBox="1"/>
          <p:nvPr/>
        </p:nvSpPr>
        <p:spPr>
          <a:xfrm>
            <a:off x="18618" y="44694"/>
            <a:ext cx="278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9"/>
          <p:cNvSpPr txBox="1"/>
          <p:nvPr/>
        </p:nvSpPr>
        <p:spPr>
          <a:xfrm>
            <a:off x="57600" y="1350131"/>
            <a:ext cx="278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oup 40"/>
          <p:cNvGrpSpPr/>
          <p:nvPr/>
        </p:nvGrpSpPr>
        <p:grpSpPr>
          <a:xfrm>
            <a:off x="447768" y="304815"/>
            <a:ext cx="6665759" cy="1065211"/>
            <a:chOff x="2328972" y="4664685"/>
            <a:chExt cx="8084493" cy="1291930"/>
          </a:xfrm>
        </p:grpSpPr>
        <p:sp>
          <p:nvSpPr>
            <p:cNvPr id="42" name="Rounded Rectangle 41"/>
            <p:cNvSpPr/>
            <p:nvPr/>
          </p:nvSpPr>
          <p:spPr>
            <a:xfrm>
              <a:off x="3178989" y="4995977"/>
              <a:ext cx="2193338" cy="696415"/>
            </a:xfrm>
            <a:prstGeom prst="roundRect">
              <a:avLst>
                <a:gd name="adj" fmla="val 8204"/>
              </a:avLst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43" name="Right Arrow 42"/>
            <p:cNvSpPr/>
            <p:nvPr/>
          </p:nvSpPr>
          <p:spPr>
            <a:xfrm>
              <a:off x="4847188" y="5059500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44" name="Right Arrow 43"/>
            <p:cNvSpPr/>
            <p:nvPr/>
          </p:nvSpPr>
          <p:spPr>
            <a:xfrm>
              <a:off x="5421076" y="5063079"/>
              <a:ext cx="2746689" cy="172474"/>
            </a:xfrm>
            <a:prstGeom prst="rightArrow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456116" y="4664685"/>
              <a:ext cx="754106" cy="335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0</a:t>
              </a:r>
              <a:endParaRPr lang="cs-CZ" sz="1200" b="1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331100" y="4664685"/>
              <a:ext cx="754106" cy="335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1</a:t>
              </a:r>
              <a:r>
                <a:rPr lang="en-US" sz="1200" b="1" dirty="0" smtClean="0"/>
                <a:t>5</a:t>
              </a:r>
              <a:endParaRPr lang="cs-CZ" sz="12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121982" y="4664685"/>
              <a:ext cx="754106" cy="335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10</a:t>
              </a:r>
              <a:endParaRPr lang="cs-CZ" sz="1200" b="1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540218" y="4664685"/>
              <a:ext cx="754106" cy="335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18</a:t>
              </a:r>
              <a:endParaRPr lang="cs-CZ" sz="1200" b="1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167765" y="5064252"/>
              <a:ext cx="2245700" cy="559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smtClean="0"/>
                <a:t>Fixation and sample proce</a:t>
              </a:r>
              <a:r>
                <a:rPr lang="en-US" sz="1200" dirty="0" smtClean="0"/>
                <a:t>s</a:t>
              </a:r>
              <a:r>
                <a:rPr lang="cs-CZ" sz="1200" dirty="0" smtClean="0"/>
                <a:t>sing/evaluation</a:t>
              </a:r>
              <a:endParaRPr lang="cs-CZ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100159" y="4664685"/>
              <a:ext cx="754106" cy="335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2</a:t>
              </a:r>
              <a:endParaRPr lang="cs-CZ" sz="1200" b="1" dirty="0"/>
            </a:p>
          </p:txBody>
        </p:sp>
        <p:sp>
          <p:nvSpPr>
            <p:cNvPr id="51" name="Right Arrow 50"/>
            <p:cNvSpPr/>
            <p:nvPr/>
          </p:nvSpPr>
          <p:spPr>
            <a:xfrm>
              <a:off x="4307022" y="5062838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52" name="Right Arrow 51"/>
            <p:cNvSpPr/>
            <p:nvPr/>
          </p:nvSpPr>
          <p:spPr>
            <a:xfrm>
              <a:off x="3794383" y="5063206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53" name="Right Arrow 52"/>
            <p:cNvSpPr/>
            <p:nvPr/>
          </p:nvSpPr>
          <p:spPr>
            <a:xfrm>
              <a:off x="3263742" y="5057019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328972" y="4974447"/>
              <a:ext cx="892039" cy="641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smtClean="0"/>
                <a:t>Cell seeded</a:t>
              </a:r>
              <a:endParaRPr lang="cs-CZ" sz="12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526985" y="5417590"/>
              <a:ext cx="15145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 smtClean="0"/>
                <a:t>Differentiation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451157" y="5396689"/>
              <a:ext cx="2667859" cy="5599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smtClean="0">
                  <a:solidFill>
                    <a:schemeClr val="accent6">
                      <a:lumMod val="50000"/>
                    </a:schemeClr>
                  </a:solidFill>
                </a:rPr>
                <a:t>Treatment </a:t>
              </a:r>
              <a:r>
                <a:rPr lang="en-US" sz="1200" dirty="0" smtClean="0">
                  <a:solidFill>
                    <a:schemeClr val="accent6">
                      <a:lumMod val="50000"/>
                    </a:schemeClr>
                  </a:solidFill>
                </a:rPr>
                <a:t>with </a:t>
              </a:r>
              <a:r>
                <a:rPr lang="cs-CZ" sz="1200" dirty="0" smtClean="0">
                  <a:solidFill>
                    <a:schemeClr val="accent6">
                      <a:lumMod val="50000"/>
                    </a:schemeClr>
                  </a:solidFill>
                </a:rPr>
                <a:t>GDF11 and/or SB431542</a:t>
              </a:r>
              <a:endParaRPr lang="cs-CZ" sz="1200" dirty="0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57" name="Right Arrow 56"/>
            <p:cNvSpPr/>
            <p:nvPr/>
          </p:nvSpPr>
          <p:spPr>
            <a:xfrm>
              <a:off x="3272244" y="5316433"/>
              <a:ext cx="4895522" cy="170897"/>
            </a:xfrm>
            <a:prstGeom prst="rightArrow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</p:grpSp>
      <p:pic>
        <p:nvPicPr>
          <p:cNvPr id="60" name="Picture 59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2939" y="1662543"/>
            <a:ext cx="1544415" cy="1544415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661" y="1662543"/>
            <a:ext cx="1544415" cy="1544415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7800" y="1662543"/>
            <a:ext cx="1544415" cy="1544415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2939" y="3225170"/>
            <a:ext cx="1544415" cy="1544415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9" cstate="screen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661" y="3225170"/>
            <a:ext cx="1544415" cy="1544415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>
          <a:blip r:embed="rId11" cstate="screen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7800" y="3225170"/>
            <a:ext cx="1544415" cy="1544415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13" cstate="screen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661" y="4787798"/>
            <a:ext cx="1544415" cy="1544415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15" cstate="screen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7800" y="4787798"/>
            <a:ext cx="1544415" cy="1544415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1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2939" y="4787798"/>
            <a:ext cx="1544415" cy="1544415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1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2068" y="1816985"/>
            <a:ext cx="1235532" cy="1235532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2068" y="4942239"/>
            <a:ext cx="1235532" cy="1235532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2068" y="3379612"/>
            <a:ext cx="1235532" cy="1235532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sp>
        <p:nvSpPr>
          <p:cNvPr id="72" name="Rectangle 71"/>
          <p:cNvSpPr/>
          <p:nvPr/>
        </p:nvSpPr>
        <p:spPr>
          <a:xfrm>
            <a:off x="4753986" y="2513367"/>
            <a:ext cx="386104" cy="38610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4456142" y="4213253"/>
            <a:ext cx="386104" cy="38610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4681341" y="5629825"/>
            <a:ext cx="386104" cy="38610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5" name="Straight Connector 74"/>
          <p:cNvCxnSpPr/>
          <p:nvPr/>
        </p:nvCxnSpPr>
        <p:spPr>
          <a:xfrm flipH="1">
            <a:off x="5140089" y="1816985"/>
            <a:ext cx="431979" cy="696382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H="1" flipV="1">
            <a:off x="5140090" y="2897378"/>
            <a:ext cx="431978" cy="16285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H="1" flipV="1">
            <a:off x="4834982" y="4588741"/>
            <a:ext cx="737086" cy="26403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H="1">
            <a:off x="4842246" y="3361400"/>
            <a:ext cx="729822" cy="851853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flipH="1">
            <a:off x="5065157" y="4942239"/>
            <a:ext cx="506911" cy="692499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H="1" flipV="1">
            <a:off x="5065157" y="6022118"/>
            <a:ext cx="506911" cy="154442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1" name="Object 8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6079843"/>
              </p:ext>
            </p:extLst>
          </p:nvPr>
        </p:nvGraphicFramePr>
        <p:xfrm>
          <a:off x="281412" y="6480131"/>
          <a:ext cx="3151188" cy="3233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56" name="Prism 8" r:id="rId21" imgW="3267151" imgH="3347992" progId="Prism8.Document">
                  <p:embed/>
                </p:oleObj>
              </mc:Choice>
              <mc:Fallback>
                <p:oleObj name="Prism 8" r:id="rId21" imgW="3267151" imgH="33479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81412" y="6480131"/>
                        <a:ext cx="3151188" cy="3233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2" name="Rectangle 81"/>
          <p:cNvSpPr/>
          <p:nvPr/>
        </p:nvSpPr>
        <p:spPr>
          <a:xfrm>
            <a:off x="2707562" y="6659308"/>
            <a:ext cx="4190038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GDF11 treatment compromises </a:t>
            </a:r>
            <a:r>
              <a:rPr lang="cs-CZ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GBS cells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fferentiation into adipocytes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ematic representation illustrating SGBS cell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 differentiating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treatment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ocol used in this study.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 of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DIPY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ed lipid droplets in CTL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DF11 (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0ng/ml)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GDF11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0ng/ml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SB431542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0nM) treated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GBS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during the whole differentiation period (18 days) (Lipids-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lei=white,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ale=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/5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μm).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racellular lipid levels quantification by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DIPY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surement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SGBS cells as in B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4 per treatment group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p&lt;0.05 ** p&lt;0.01 (Mann-Whitney U-test)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859204" y="1395131"/>
            <a:ext cx="781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372898" y="1397505"/>
            <a:ext cx="781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DIPY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984493" y="1398061"/>
            <a:ext cx="781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16200000">
            <a:off x="-73012" y="2273613"/>
            <a:ext cx="723975" cy="255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 rot="16200000">
            <a:off x="-536619" y="3885501"/>
            <a:ext cx="16698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DF11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00 ng/ml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6200000">
            <a:off x="-487723" y="5390088"/>
            <a:ext cx="155975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DF11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00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g/ml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SB431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42 50nM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9304758"/>
      </p:ext>
    </p:extLst>
  </p:cSld>
  <p:clrMapOvr>
    <a:masterClrMapping/>
  </p:clrMapOvr>
  <p:transition xmlns:p14="http://schemas.microsoft.com/office/powerpoint/2010/main" spd="slow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8"/>
          <p:cNvSpPr txBox="1"/>
          <p:nvPr/>
        </p:nvSpPr>
        <p:spPr>
          <a:xfrm>
            <a:off x="105512" y="6859259"/>
            <a:ext cx="247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8"/>
          <p:cNvSpPr txBox="1"/>
          <p:nvPr/>
        </p:nvSpPr>
        <p:spPr>
          <a:xfrm>
            <a:off x="18618" y="44694"/>
            <a:ext cx="278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9"/>
          <p:cNvSpPr txBox="1"/>
          <p:nvPr/>
        </p:nvSpPr>
        <p:spPr>
          <a:xfrm>
            <a:off x="48618" y="1338701"/>
            <a:ext cx="278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193919" y="1530131"/>
            <a:ext cx="781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440014" y="1530131"/>
            <a:ext cx="781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DIPY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967884" y="1530131"/>
            <a:ext cx="781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cs-CZ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Group 58"/>
          <p:cNvGrpSpPr/>
          <p:nvPr/>
        </p:nvGrpSpPr>
        <p:grpSpPr>
          <a:xfrm>
            <a:off x="462138" y="1603060"/>
            <a:ext cx="6018103" cy="5078153"/>
            <a:chOff x="276947" y="1269000"/>
            <a:chExt cx="6605807" cy="5574066"/>
          </a:xfrm>
        </p:grpSpPr>
        <p:pic>
          <p:nvPicPr>
            <p:cNvPr id="83" name="Picture 82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6947" y="1269000"/>
              <a:ext cx="2167467" cy="1828800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000" y="3137503"/>
              <a:ext cx="2167467" cy="1828800"/>
            </a:xfrm>
            <a:prstGeom prst="rect">
              <a:avLst/>
            </a:prstGeom>
          </p:spPr>
        </p:pic>
        <p:pic>
          <p:nvPicPr>
            <p:cNvPr id="91" name="Picture 90"/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000" y="5014266"/>
              <a:ext cx="2167467" cy="1828800"/>
            </a:xfrm>
            <a:prstGeom prst="rect">
              <a:avLst/>
            </a:prstGeom>
          </p:spPr>
        </p:pic>
        <p:pic>
          <p:nvPicPr>
            <p:cNvPr id="92" name="Picture 91"/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2938" y="1497600"/>
              <a:ext cx="1371600" cy="1371600"/>
            </a:xfrm>
            <a:prstGeom prst="rect">
              <a:avLst/>
            </a:prstGeom>
          </p:spPr>
        </p:pic>
        <p:pic>
          <p:nvPicPr>
            <p:cNvPr id="93" name="Picture 92"/>
            <p:cNvPicPr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6000" y="1497600"/>
              <a:ext cx="1371600" cy="1371600"/>
            </a:xfrm>
            <a:prstGeom prst="rect">
              <a:avLst/>
            </a:prstGeom>
            <a:ln w="25400">
              <a:solidFill>
                <a:srgbClr val="FF0000"/>
              </a:solidFill>
            </a:ln>
          </p:spPr>
        </p:pic>
        <p:pic>
          <p:nvPicPr>
            <p:cNvPr id="94" name="Picture 93"/>
            <p:cNvPicPr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1154" y="1497600"/>
              <a:ext cx="1371600" cy="1371600"/>
            </a:xfrm>
            <a:prstGeom prst="rect">
              <a:avLst/>
            </a:prstGeom>
          </p:spPr>
        </p:pic>
        <p:pic>
          <p:nvPicPr>
            <p:cNvPr id="95" name="Picture 94"/>
            <p:cNvPicPr>
              <a:picLocks noChangeAspect="1"/>
            </p:cNvPicPr>
            <p:nvPr/>
          </p:nvPicPr>
          <p:blipFill>
            <a:blip r:embed="rId9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4032" y="3276908"/>
              <a:ext cx="1371600" cy="1371600"/>
            </a:xfrm>
            <a:prstGeom prst="rect">
              <a:avLst/>
            </a:prstGeom>
          </p:spPr>
        </p:pic>
        <p:pic>
          <p:nvPicPr>
            <p:cNvPr id="96" name="Picture 95"/>
            <p:cNvPicPr>
              <a:picLocks noChangeAspect="1"/>
            </p:cNvPicPr>
            <p:nvPr/>
          </p:nvPicPr>
          <p:blipFill>
            <a:blip r:embed="rId10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6000" y="3276908"/>
              <a:ext cx="1371600" cy="1371600"/>
            </a:xfrm>
            <a:prstGeom prst="rect">
              <a:avLst/>
            </a:prstGeom>
            <a:ln w="25400">
              <a:solidFill>
                <a:srgbClr val="FF0000"/>
              </a:solidFill>
            </a:ln>
          </p:spPr>
        </p:pic>
        <p:pic>
          <p:nvPicPr>
            <p:cNvPr id="97" name="Picture 96"/>
            <p:cNvPicPr>
              <a:picLocks noChangeAspect="1"/>
            </p:cNvPicPr>
            <p:nvPr/>
          </p:nvPicPr>
          <p:blipFill>
            <a:blip r:embed="rId11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1154" y="3276908"/>
              <a:ext cx="1371600" cy="1371600"/>
            </a:xfrm>
            <a:prstGeom prst="rect">
              <a:avLst/>
            </a:prstGeom>
          </p:spPr>
        </p:pic>
        <p:pic>
          <p:nvPicPr>
            <p:cNvPr id="98" name="Picture 97"/>
            <p:cNvPicPr>
              <a:picLocks noChangeAspect="1"/>
            </p:cNvPicPr>
            <p:nvPr/>
          </p:nvPicPr>
          <p:blipFill>
            <a:blip r:embed="rId12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5716" y="5149266"/>
              <a:ext cx="1371600" cy="1371600"/>
            </a:xfrm>
            <a:prstGeom prst="rect">
              <a:avLst/>
            </a:prstGeom>
          </p:spPr>
        </p:pic>
        <p:pic>
          <p:nvPicPr>
            <p:cNvPr id="99" name="Picture 98"/>
            <p:cNvPicPr>
              <a:picLocks noChangeAspect="1"/>
            </p:cNvPicPr>
            <p:nvPr/>
          </p:nvPicPr>
          <p:blipFill>
            <a:blip r:embed="rId13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1154" y="5149266"/>
              <a:ext cx="1371600" cy="1371600"/>
            </a:xfrm>
            <a:prstGeom prst="rect">
              <a:avLst/>
            </a:prstGeom>
          </p:spPr>
        </p:pic>
        <p:pic>
          <p:nvPicPr>
            <p:cNvPr id="101" name="Picture 100"/>
            <p:cNvPicPr>
              <a:picLocks noChangeAspect="1"/>
            </p:cNvPicPr>
            <p:nvPr/>
          </p:nvPicPr>
          <p:blipFill>
            <a:blip r:embed="rId14" cstate="screen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6000" y="5149266"/>
              <a:ext cx="1371600" cy="1371600"/>
            </a:xfrm>
            <a:prstGeom prst="rect">
              <a:avLst/>
            </a:prstGeom>
            <a:ln w="25400">
              <a:solidFill>
                <a:srgbClr val="FF0000"/>
              </a:solidFill>
            </a:ln>
          </p:spPr>
        </p:pic>
        <p:sp>
          <p:nvSpPr>
            <p:cNvPr id="104" name="Rectangle 103"/>
            <p:cNvSpPr/>
            <p:nvPr/>
          </p:nvSpPr>
          <p:spPr>
            <a:xfrm>
              <a:off x="1747792" y="1279300"/>
              <a:ext cx="682000" cy="68200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1391834" y="3667911"/>
              <a:ext cx="682000" cy="68200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1575984" y="5501961"/>
              <a:ext cx="682000" cy="68200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7" name="Straight Connector 106"/>
            <p:cNvCxnSpPr/>
            <p:nvPr/>
          </p:nvCxnSpPr>
          <p:spPr>
            <a:xfrm>
              <a:off x="2429792" y="1279300"/>
              <a:ext cx="246208" cy="21830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2425260" y="1961300"/>
              <a:ext cx="241740" cy="919291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2073834" y="4346104"/>
              <a:ext cx="588404" cy="306137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 flipV="1">
              <a:off x="2073834" y="3261591"/>
              <a:ext cx="597929" cy="405135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 flipV="1">
              <a:off x="2245284" y="5128979"/>
              <a:ext cx="421716" cy="386085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2264528" y="6183962"/>
              <a:ext cx="397710" cy="336904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9" name="Rectangle 128"/>
          <p:cNvSpPr/>
          <p:nvPr/>
        </p:nvSpPr>
        <p:spPr>
          <a:xfrm>
            <a:off x="2847600" y="6862475"/>
            <a:ext cx="4382956" cy="2677656"/>
          </a:xfrm>
          <a:prstGeom prst="rect">
            <a:avLst/>
          </a:prstGeom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Co-treatment of 3T3-L1 cells with GDF11 an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tent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PAR</a:t>
            </a:r>
            <a:r>
              <a:rPr lang="el-GR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γ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onist</a:t>
            </a:r>
            <a:r>
              <a:rPr lang="cs-CZ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W1929 does not rescue GDF11 mediated decrease of </a:t>
            </a:r>
            <a:r>
              <a:rPr lang="en-US" sz="1200" b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ipogenic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fferentiation.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ematic figure illustrating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T3-L1 cell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iati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 and treatment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ocol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ed in thi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eriment.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 of 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DIPY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ed lipid droplets in CTL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DF11 (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0ng/ml)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DF11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100ng/ml)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W1929 (100nM) treated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T3-L1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ring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whol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iation period (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ys) (Lipids-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lei=white,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ale=1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/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μm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rease of PPAR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s not the main mechanism of GDF11 action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ipogeni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fferentiation, this process i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r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lex and other pathways, mechanisms and transcription factor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y be involved.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racellular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pid levels quantification by </a:t>
            </a:r>
            <a:r>
              <a:rPr lang="cs-CZ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DIPY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surement </a:t>
            </a:r>
            <a:r>
              <a:rPr lang="cs-CZ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 in B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t least n=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 group)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 p&lt;0.001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Mann-Whitney U-test)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0" name="Object 1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0921552"/>
              </p:ext>
            </p:extLst>
          </p:nvPr>
        </p:nvGraphicFramePr>
        <p:xfrm>
          <a:off x="372600" y="6750131"/>
          <a:ext cx="2746375" cy="2890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8" name="Prism 8" r:id="rId15" imgW="2745675" imgH="2890596" progId="Prism8.Document">
                  <p:embed/>
                </p:oleObj>
              </mc:Choice>
              <mc:Fallback>
                <p:oleObj name="Prism 8" r:id="rId15" imgW="2745675" imgH="289059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72600" y="6750131"/>
                        <a:ext cx="2746375" cy="2890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1" name="TextBox 130"/>
          <p:cNvSpPr txBox="1"/>
          <p:nvPr/>
        </p:nvSpPr>
        <p:spPr>
          <a:xfrm>
            <a:off x="126422" y="1537079"/>
            <a:ext cx="369332" cy="164079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cs-CZ" sz="1200" b="1" dirty="0" smtClean="0"/>
              <a:t>CTL</a:t>
            </a:r>
            <a:endParaRPr lang="en-US" sz="1200" b="1" dirty="0"/>
          </a:p>
        </p:txBody>
      </p:sp>
      <p:sp>
        <p:nvSpPr>
          <p:cNvPr id="132" name="TextBox 131"/>
          <p:cNvSpPr txBox="1"/>
          <p:nvPr/>
        </p:nvSpPr>
        <p:spPr>
          <a:xfrm>
            <a:off x="149140" y="3247079"/>
            <a:ext cx="369332" cy="164079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cs-CZ" sz="1200" b="1" dirty="0" smtClean="0"/>
              <a:t>GDF11 </a:t>
            </a:r>
            <a:r>
              <a:rPr lang="en-US" sz="1200" b="1" dirty="0" smtClean="0"/>
              <a:t>10</a:t>
            </a:r>
            <a:r>
              <a:rPr lang="cs-CZ" sz="1200" b="1" dirty="0" smtClean="0"/>
              <a:t>0ng/ml</a:t>
            </a:r>
            <a:endParaRPr lang="en-US" sz="1200" b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3348" y="5081089"/>
            <a:ext cx="553998" cy="151678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cs-CZ" sz="1200" b="1" dirty="0" smtClean="0"/>
              <a:t>GDF11 </a:t>
            </a:r>
            <a:r>
              <a:rPr lang="en-US" sz="1200" b="1" dirty="0" smtClean="0"/>
              <a:t>10</a:t>
            </a:r>
            <a:r>
              <a:rPr lang="cs-CZ" sz="1200" b="1" dirty="0" smtClean="0"/>
              <a:t>0ng/ml</a:t>
            </a:r>
            <a:r>
              <a:rPr lang="en-US" sz="1200" b="1" dirty="0" smtClean="0"/>
              <a:t> </a:t>
            </a:r>
            <a:r>
              <a:rPr lang="cs-CZ" sz="1200" b="1" dirty="0" smtClean="0"/>
              <a:t>+</a:t>
            </a:r>
            <a:r>
              <a:rPr lang="en-US" sz="1200" b="1" dirty="0" smtClean="0"/>
              <a:t>GW1929 10</a:t>
            </a:r>
            <a:r>
              <a:rPr lang="cs-CZ" sz="1200" b="1" dirty="0" smtClean="0"/>
              <a:t>0nM</a:t>
            </a:r>
            <a:endParaRPr lang="en-US" sz="1200" b="1" dirty="0"/>
          </a:p>
        </p:txBody>
      </p:sp>
      <p:grpSp>
        <p:nvGrpSpPr>
          <p:cNvPr id="134" name="Group 133"/>
          <p:cNvGrpSpPr/>
          <p:nvPr/>
        </p:nvGrpSpPr>
        <p:grpSpPr>
          <a:xfrm>
            <a:off x="546551" y="201248"/>
            <a:ext cx="6569613" cy="1151705"/>
            <a:chOff x="2328972" y="4669683"/>
            <a:chExt cx="7967883" cy="1396827"/>
          </a:xfrm>
        </p:grpSpPr>
        <p:sp>
          <p:nvSpPr>
            <p:cNvPr id="135" name="Rounded Rectangle 134"/>
            <p:cNvSpPr/>
            <p:nvPr/>
          </p:nvSpPr>
          <p:spPr>
            <a:xfrm>
              <a:off x="3178989" y="4995977"/>
              <a:ext cx="2193338" cy="696415"/>
            </a:xfrm>
            <a:prstGeom prst="roundRect">
              <a:avLst>
                <a:gd name="adj" fmla="val 8204"/>
              </a:avLst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136" name="Right Arrow 135"/>
            <p:cNvSpPr/>
            <p:nvPr/>
          </p:nvSpPr>
          <p:spPr>
            <a:xfrm>
              <a:off x="4847188" y="5059500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137" name="Right Arrow 136"/>
            <p:cNvSpPr/>
            <p:nvPr/>
          </p:nvSpPr>
          <p:spPr>
            <a:xfrm>
              <a:off x="5421076" y="5063079"/>
              <a:ext cx="2746689" cy="172474"/>
            </a:xfrm>
            <a:prstGeom prst="rightArrow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431197" y="4669683"/>
              <a:ext cx="754106" cy="3359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 </a:t>
              </a:r>
              <a:r>
                <a:rPr lang="cs-CZ" sz="1200" b="1" dirty="0" smtClean="0"/>
                <a:t>0</a:t>
              </a:r>
              <a:endParaRPr lang="cs-CZ" sz="1200" b="1" dirty="0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6331099" y="4669683"/>
              <a:ext cx="754106" cy="3359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 7</a:t>
              </a:r>
              <a:endParaRPr lang="cs-CZ" sz="1200" b="1" dirty="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5121983" y="4669683"/>
              <a:ext cx="754106" cy="3359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 5</a:t>
              </a:r>
              <a:endParaRPr lang="cs-CZ" sz="1200" b="1" dirty="0"/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7540217" y="4669683"/>
              <a:ext cx="754106" cy="3359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 </a:t>
              </a:r>
              <a:r>
                <a:rPr lang="cs-CZ" sz="1200" b="1" dirty="0" smtClean="0"/>
                <a:t>1</a:t>
              </a:r>
              <a:r>
                <a:rPr lang="en-US" sz="1200" b="1" dirty="0" smtClean="0"/>
                <a:t>0</a:t>
              </a:r>
              <a:endParaRPr lang="cs-CZ" sz="1200" b="1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8051155" y="5044556"/>
              <a:ext cx="2245700" cy="5599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smtClean="0"/>
                <a:t>Fixation and sample proce</a:t>
              </a:r>
              <a:r>
                <a:rPr lang="en-US" sz="1200" dirty="0" smtClean="0"/>
                <a:t>s</a:t>
              </a:r>
              <a:r>
                <a:rPr lang="cs-CZ" sz="1200" dirty="0" smtClean="0"/>
                <a:t>sing/evaluation</a:t>
              </a:r>
              <a:endParaRPr lang="cs-CZ" sz="1200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2976975" y="4669683"/>
              <a:ext cx="754106" cy="3359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200" b="1" dirty="0" smtClean="0"/>
                <a:t>Day</a:t>
              </a:r>
              <a:r>
                <a:rPr lang="en-US" sz="1200" b="1" dirty="0" smtClean="0"/>
                <a:t> </a:t>
              </a:r>
              <a:r>
                <a:rPr lang="cs-CZ" sz="1200" b="1" dirty="0" smtClean="0"/>
                <a:t>2</a:t>
              </a:r>
              <a:endParaRPr lang="cs-CZ" sz="1200" b="1" dirty="0"/>
            </a:p>
          </p:txBody>
        </p:sp>
        <p:sp>
          <p:nvSpPr>
            <p:cNvPr id="144" name="Right Arrow 143"/>
            <p:cNvSpPr/>
            <p:nvPr/>
          </p:nvSpPr>
          <p:spPr>
            <a:xfrm>
              <a:off x="4307022" y="5062838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145" name="Right Arrow 144"/>
            <p:cNvSpPr/>
            <p:nvPr/>
          </p:nvSpPr>
          <p:spPr>
            <a:xfrm>
              <a:off x="3794383" y="5063206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146" name="Right Arrow 145"/>
            <p:cNvSpPr/>
            <p:nvPr/>
          </p:nvSpPr>
          <p:spPr>
            <a:xfrm>
              <a:off x="3263742" y="5057019"/>
              <a:ext cx="445100" cy="1421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2328972" y="4974446"/>
              <a:ext cx="892039" cy="559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smtClean="0"/>
                <a:t>Cell</a:t>
              </a:r>
              <a:r>
                <a:rPr lang="en-US" sz="1200" dirty="0" smtClean="0"/>
                <a:t>s</a:t>
              </a:r>
              <a:r>
                <a:rPr lang="cs-CZ" sz="1200" dirty="0" smtClean="0"/>
                <a:t> seeded</a:t>
              </a:r>
              <a:endParaRPr lang="cs-CZ" sz="1200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499854" y="5165010"/>
              <a:ext cx="15145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 smtClean="0"/>
                <a:t>Differentiation</a:t>
              </a: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265659" y="5506587"/>
              <a:ext cx="2251177" cy="559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>
                  <a:solidFill>
                    <a:schemeClr val="accent6">
                      <a:lumMod val="50000"/>
                    </a:schemeClr>
                  </a:solidFill>
                </a:rPr>
                <a:t>Treatment</a:t>
              </a:r>
              <a:r>
                <a:rPr lang="en-US" sz="1200" dirty="0">
                  <a:solidFill>
                    <a:schemeClr val="accent6">
                      <a:lumMod val="50000"/>
                    </a:schemeClr>
                  </a:solidFill>
                </a:rPr>
                <a:t> with</a:t>
              </a:r>
              <a:r>
                <a:rPr lang="cs-CZ" sz="1200" dirty="0">
                  <a:solidFill>
                    <a:schemeClr val="accent6">
                      <a:lumMod val="50000"/>
                    </a:schemeClr>
                  </a:solidFill>
                </a:rPr>
                <a:t> GDF11</a:t>
              </a:r>
              <a:r>
                <a:rPr lang="en-US" sz="1200" dirty="0">
                  <a:solidFill>
                    <a:schemeClr val="accent6">
                      <a:lumMod val="50000"/>
                    </a:schemeClr>
                  </a:solidFill>
                </a:rPr>
                <a:t> and/or GW1929</a:t>
              </a:r>
              <a:endParaRPr lang="cs-CZ" sz="1200" dirty="0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150" name="Right Arrow 149"/>
            <p:cNvSpPr/>
            <p:nvPr/>
          </p:nvSpPr>
          <p:spPr>
            <a:xfrm>
              <a:off x="3272244" y="5436328"/>
              <a:ext cx="4895522" cy="170897"/>
            </a:xfrm>
            <a:prstGeom prst="rightArrow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</p:grpSp>
    </p:spTree>
    <p:extLst>
      <p:ext uri="{BB962C8B-B14F-4D97-AF65-F5344CB8AC3E}">
        <p14:creationId xmlns:p14="http://schemas.microsoft.com/office/powerpoint/2010/main" val="3313810413"/>
      </p:ext>
    </p:extLst>
  </p:cSld>
  <p:clrMapOvr>
    <a:masterClrMapping/>
  </p:clrMapOvr>
  <p:transition xmlns:p14="http://schemas.microsoft.com/office/powerpoint/2010/main" spd="slow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728</TotalTime>
  <Words>495</Words>
  <Application>Microsoft Macintosh PowerPoint</Application>
  <PresentationFormat>Custom</PresentationFormat>
  <Paragraphs>65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8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Manlio Vinciguerra</cp:lastModifiedBy>
  <cp:revision>403</cp:revision>
  <cp:lastPrinted>2019-07-25T09:02:33Z</cp:lastPrinted>
  <dcterms:created xsi:type="dcterms:W3CDTF">2019-06-07T07:40:26Z</dcterms:created>
  <dcterms:modified xsi:type="dcterms:W3CDTF">2022-02-19T17:37:59Z</dcterms:modified>
</cp:coreProperties>
</file>